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128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64769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26655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0313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3238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8424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23673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6652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6592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138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99680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2097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A6B8C-E7F7-4418-95DF-7AEC212CE213}" type="datetimeFigureOut">
              <a:rPr lang="en-CA" smtClean="0"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8F681-0066-4DED-BAD7-47D029B8ACF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7228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48" y="208334"/>
            <a:ext cx="3960000" cy="30800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0966" y="208334"/>
            <a:ext cx="3960000" cy="30800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3950" y="3736810"/>
            <a:ext cx="3960000" cy="30800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8467" y="-1199"/>
            <a:ext cx="5715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000" b="1" dirty="0">
                <a:latin typeface="Century Gothic" panose="020B0502020202020204" pitchFamily="34" charset="0"/>
              </a:rPr>
              <a:t>(a)</a:t>
            </a:r>
            <a:endParaRPr lang="en-CA" sz="1400" b="1" dirty="0">
              <a:latin typeface="Century Gothic" panose="020B0502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914902" y="15735"/>
            <a:ext cx="6138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000" b="1" dirty="0">
                <a:latin typeface="Century Gothic" panose="020B0502020202020204" pitchFamily="34" charset="0"/>
              </a:rPr>
              <a:t>(b)</a:t>
            </a:r>
            <a:endParaRPr lang="en-CA" sz="1400" b="1" dirty="0">
              <a:latin typeface="Century Gothic" panose="020B0502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393950" y="3524876"/>
            <a:ext cx="6138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000" b="1" dirty="0">
                <a:latin typeface="Century Gothic" panose="020B0502020202020204" pitchFamily="34" charset="0"/>
              </a:rPr>
              <a:t>(c)</a:t>
            </a:r>
            <a:endParaRPr lang="en-CA" sz="1400" b="1" dirty="0">
              <a:latin typeface="Century Gothic" panose="020B0502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7759" y="3037273"/>
            <a:ext cx="366594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Early-season size (mm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78678" y="3039425"/>
            <a:ext cx="366594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Early-season size (mm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07786" y="6519463"/>
            <a:ext cx="366594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Early-season size (mm)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811026" y="1445151"/>
            <a:ext cx="196060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% defoliation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4067490" y="1445151"/>
            <a:ext cx="196060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% defoliation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519130" y="4998167"/>
            <a:ext cx="196060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% defoliation</a:t>
            </a:r>
          </a:p>
        </p:txBody>
      </p:sp>
    </p:spTree>
    <p:extLst>
      <p:ext uri="{BB962C8B-B14F-4D97-AF65-F5344CB8AC3E}">
        <p14:creationId xmlns:p14="http://schemas.microsoft.com/office/powerpoint/2010/main" val="2398792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47</TotalTime>
  <Words>30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entury Gothic</vt:lpstr>
      <vt:lpstr>Office Theme</vt:lpstr>
      <vt:lpstr>PowerPoint Presentation</vt:lpstr>
    </vt:vector>
  </TitlesOfParts>
  <Company>NRCan  /  RNCa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stny, Michael</dc:creator>
  <cp:lastModifiedBy>Risa Sargent</cp:lastModifiedBy>
  <cp:revision>87</cp:revision>
  <dcterms:created xsi:type="dcterms:W3CDTF">2019-08-29T15:42:37Z</dcterms:created>
  <dcterms:modified xsi:type="dcterms:W3CDTF">2020-06-24T19:04:37Z</dcterms:modified>
</cp:coreProperties>
</file>